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44249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841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0885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9933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0223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2202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24776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4763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5200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0331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1082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269DD-9625-4F9D-B16F-456E83B474E7}" type="datetimeFigureOut">
              <a:rPr lang="de-DE" smtClean="0"/>
              <a:t>29.09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4BBB16-6B2C-413E-B06D-0530AB2571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2529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7671886"/>
              </p:ext>
            </p:extLst>
          </p:nvPr>
        </p:nvGraphicFramePr>
        <p:xfrm>
          <a:off x="179512" y="2523736"/>
          <a:ext cx="8229595" cy="13373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48145"/>
                <a:gridCol w="748145"/>
                <a:gridCol w="748145"/>
                <a:gridCol w="748145"/>
                <a:gridCol w="748145"/>
                <a:gridCol w="748145"/>
                <a:gridCol w="748145"/>
                <a:gridCol w="748145"/>
                <a:gridCol w="748145"/>
                <a:gridCol w="748145"/>
                <a:gridCol w="748145"/>
              </a:tblGrid>
              <a:tr h="327314"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 err="1">
                          <a:effectLst/>
                        </a:rPr>
                        <a:t>ng</a:t>
                      </a:r>
                      <a:r>
                        <a:rPr lang="de-DE" sz="900" b="1" u="none" strike="noStrike" dirty="0">
                          <a:effectLst/>
                        </a:rPr>
                        <a:t> MMP-2 </a:t>
                      </a:r>
                      <a:r>
                        <a:rPr lang="de-DE" sz="900" b="1" u="none" strike="noStrike" dirty="0" err="1">
                          <a:effectLst/>
                        </a:rPr>
                        <a:t>standard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el1-value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el1-value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el2-value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el2-value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el3-value2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Gel3-value1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Gel4-value1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Gel4-value1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>
                          <a:effectLst/>
                        </a:rPr>
                        <a:t>Average</a:t>
                      </a:r>
                      <a:endParaRPr lang="de-DE" sz="9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900" b="1" u="none" strike="noStrike" dirty="0">
                          <a:effectLst/>
                        </a:rPr>
                        <a:t>S</a:t>
                      </a:r>
                      <a:r>
                        <a:rPr lang="de-DE" sz="900" b="1" u="none" strike="noStrike" dirty="0" smtClean="0">
                          <a:effectLst/>
                        </a:rPr>
                        <a:t>tandard </a:t>
                      </a:r>
                      <a:r>
                        <a:rPr lang="de-DE" sz="900" b="1" u="none" strike="noStrike" dirty="0">
                          <a:effectLst/>
                        </a:rPr>
                        <a:t>D</a:t>
                      </a:r>
                      <a:r>
                        <a:rPr lang="de-DE" sz="900" b="1" u="none" strike="noStrike" dirty="0" smtClean="0">
                          <a:effectLst/>
                        </a:rPr>
                        <a:t>eviation</a:t>
                      </a:r>
                      <a:endParaRPr lang="de-DE" sz="9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</a:tr>
              <a:tr h="168333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.5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141168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849481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83805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411347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6806589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0509288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7454276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5043418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7121183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757791.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</a:tr>
              <a:tr h="168333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.2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469210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5267933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81384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791225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565864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565171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995305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955619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4103297.25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357034.69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</a:tr>
              <a:tr h="168333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0.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87215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076213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379083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592447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58910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015447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669548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154033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168503.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838736.657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</a:tr>
              <a:tr h="168333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0.3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75766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666042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1592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89577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859669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29213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83849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504506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008669.63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838423.86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</a:tr>
              <a:tr h="168333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0.16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461577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84699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7199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95607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054355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53287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56092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439935.3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40297.632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</a:tr>
              <a:tr h="168333"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0.0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450991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367042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9631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492284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37263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34849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0.00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209842.88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900" u="none" strike="noStrike" dirty="0" smtClean="0">
                          <a:effectLst/>
                        </a:rPr>
                        <a:t>185231.531</a:t>
                      </a:r>
                      <a:endParaRPr lang="de-DE" sz="9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52" marR="9352" marT="9352" marB="0" anchor="b"/>
                </a:tc>
              </a:tr>
            </a:tbl>
          </a:graphicData>
        </a:graphic>
      </p:graphicFrame>
      <p:sp>
        <p:nvSpPr>
          <p:cNvPr id="3" name="Rechteck 2"/>
          <p:cNvSpPr/>
          <p:nvPr/>
        </p:nvSpPr>
        <p:spPr>
          <a:xfrm>
            <a:off x="132558" y="1515624"/>
            <a:ext cx="825586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50000"/>
              </a:lnSpc>
            </a:pP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 Table. 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>
              <a:lnSpc>
                <a:spcPct val="150000"/>
              </a:lnSpc>
            </a:pP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onship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MP-2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ount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aded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ymograms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sity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ferent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ount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human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ngth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MP-2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ad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nto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ymogram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l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scrib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tal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xel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nsitie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different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zymogram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wic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ame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l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ndar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rv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 was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verag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</a:t>
            </a:r>
            <a:r>
              <a:rPr lang="de-DE" sz="10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1.</a:t>
            </a:r>
            <a:endParaRPr lang="de-DE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163740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Bildschirmpräsentation (4:3)</PresentationFormat>
  <Paragraphs>7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Anke Tscheuschler</dc:creator>
  <cp:lastModifiedBy>Dr. Anke Tscheuschler</cp:lastModifiedBy>
  <cp:revision>1</cp:revision>
  <dcterms:created xsi:type="dcterms:W3CDTF">2016-09-29T14:07:25Z</dcterms:created>
  <dcterms:modified xsi:type="dcterms:W3CDTF">2016-09-29T14:08:02Z</dcterms:modified>
</cp:coreProperties>
</file>